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1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76" autoAdjust="0"/>
    <p:restoredTop sz="92986" autoAdjust="0"/>
  </p:normalViewPr>
  <p:slideViewPr>
    <p:cSldViewPr snapToGrid="0" snapToObjects="1">
      <p:cViewPr varScale="1">
        <p:scale>
          <a:sx n="59" d="100"/>
          <a:sy n="59" d="100"/>
        </p:scale>
        <p:origin x="2892" y="72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263235-826B-4DBE-BF6E-0C185A76ABA3}" type="datetimeFigureOut">
              <a:rPr lang="zh-CN" altLang="en-US" smtClean="0"/>
              <a:pPr/>
              <a:t>2018/8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50AFE5-DE01-4638-B01A-C45FD2F995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438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13318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827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571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967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7538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147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580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888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69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457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855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272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75" t="4767" r="19650" b="7329"/>
          <a:stretch/>
        </p:blipFill>
        <p:spPr>
          <a:xfrm>
            <a:off x="2742118" y="1520433"/>
            <a:ext cx="3401855" cy="4298640"/>
          </a:xfrm>
        </p:spPr>
      </p:pic>
      <p:sp>
        <p:nvSpPr>
          <p:cNvPr id="5" name="文本框 4"/>
          <p:cNvSpPr txBox="1"/>
          <p:nvPr/>
        </p:nvSpPr>
        <p:spPr>
          <a:xfrm>
            <a:off x="6058084" y="3432426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logical process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48"/>
          <p:cNvSpPr txBox="1"/>
          <p:nvPr/>
        </p:nvSpPr>
        <p:spPr>
          <a:xfrm>
            <a:off x="6058084" y="3640754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function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48"/>
          <p:cNvSpPr txBox="1"/>
          <p:nvPr/>
        </p:nvSpPr>
        <p:spPr>
          <a:xfrm>
            <a:off x="3633510" y="5886277"/>
            <a:ext cx="1252566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og10(</a:t>
            </a:r>
            <a:r>
              <a:rPr lang="en-US" altLang="zh-CN" sz="1323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value</a:t>
            </a:r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3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48"/>
          <p:cNvSpPr txBox="1"/>
          <p:nvPr/>
        </p:nvSpPr>
        <p:spPr>
          <a:xfrm>
            <a:off x="3063357" y="1281511"/>
            <a:ext cx="2648440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ost enriched GO terms</a:t>
            </a:r>
            <a:endParaRPr lang="zh-CN" altLang="en-US" sz="13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048662" y="1554177"/>
            <a:ext cx="1836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threonine ammonia-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yas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09748" y="1751817"/>
            <a:ext cx="252756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-affinity 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drogen:glucos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mporter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397699" y="1959273"/>
            <a:ext cx="15076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con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omer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921268" y="2796595"/>
            <a:ext cx="95868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r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on bind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372288" y="2174264"/>
            <a:ext cx="151078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yridoxal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sphate bind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251224" y="2379316"/>
            <a:ext cx="21653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ctinesteras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530397" y="2591781"/>
            <a:ext cx="21653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partyl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ter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652750" y="3008828"/>
            <a:ext cx="12592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ctinesterase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493336" y="3215795"/>
            <a:ext cx="135697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id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sphat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245130" y="3424580"/>
            <a:ext cx="16148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oleucin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synthet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162280" y="3637045"/>
            <a:ext cx="17767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lling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cells of other organism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471101" y="3840838"/>
            <a:ext cx="16148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tin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synthet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893018" y="4060783"/>
            <a:ext cx="197694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ulation of catalytic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808708" y="4263878"/>
            <a:ext cx="107124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ino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id impor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429466" y="4476343"/>
            <a:ext cx="147024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fen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 to fungu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956897" y="4682932"/>
            <a:ext cx="91306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co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port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803482" y="4888011"/>
            <a:ext cx="107124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phosphorylatio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273563" y="5097184"/>
            <a:ext cx="169815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avonoid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synthet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1570031" y="5300279"/>
            <a:ext cx="142470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cti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tabol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1641668" y="5512743"/>
            <a:ext cx="142470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ll modificatio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2808520" y="5739470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26"/>
          <p:cNvSpPr txBox="1"/>
          <p:nvPr/>
        </p:nvSpPr>
        <p:spPr>
          <a:xfrm>
            <a:off x="3505994" y="5738555"/>
            <a:ext cx="30094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26"/>
          <p:cNvSpPr txBox="1"/>
          <p:nvPr/>
        </p:nvSpPr>
        <p:spPr>
          <a:xfrm>
            <a:off x="4199063" y="5742070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26"/>
          <p:cNvSpPr txBox="1"/>
          <p:nvPr/>
        </p:nvSpPr>
        <p:spPr>
          <a:xfrm>
            <a:off x="4902184" y="5745713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26"/>
          <p:cNvSpPr txBox="1"/>
          <p:nvPr/>
        </p:nvSpPr>
        <p:spPr>
          <a:xfrm>
            <a:off x="5585897" y="5748817"/>
            <a:ext cx="24201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5371384" y="1572917"/>
            <a:ext cx="26629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5364515" y="1758736"/>
            <a:ext cx="265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4384350" y="1987643"/>
            <a:ext cx="265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4050706" y="2200848"/>
            <a:ext cx="265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3968785" y="2411751"/>
            <a:ext cx="265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3821895" y="2608233"/>
            <a:ext cx="265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3822015" y="2830474"/>
            <a:ext cx="265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3815867" y="3031956"/>
            <a:ext cx="265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3749160" y="3224665"/>
            <a:ext cx="265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5123733" y="3459230"/>
            <a:ext cx="265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5121257" y="3634635"/>
            <a:ext cx="265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4187065" y="3871681"/>
            <a:ext cx="265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3958170" y="4076149"/>
            <a:ext cx="265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3927075" y="4292836"/>
            <a:ext cx="265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3927574" y="4494698"/>
            <a:ext cx="265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3762719" y="4701369"/>
            <a:ext cx="265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3760242" y="4906422"/>
            <a:ext cx="265750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3751922" y="5125498"/>
            <a:ext cx="24925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3749445" y="5315727"/>
            <a:ext cx="24925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3754374" y="5520779"/>
            <a:ext cx="24925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矩形 60"/>
          <p:cNvSpPr/>
          <p:nvPr/>
        </p:nvSpPr>
        <p:spPr>
          <a:xfrm>
            <a:off x="42402" y="363852"/>
            <a:ext cx="683200" cy="29591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323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Fig. </a:t>
            </a:r>
            <a:r>
              <a:rPr lang="en-US" altLang="zh-CN" sz="1323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S2</a:t>
            </a:r>
            <a:endParaRPr lang="en-US" altLang="zh-CN" sz="1323" b="1" dirty="0">
              <a:latin typeface="Times New Roman" panose="02020603050405020304" pitchFamily="18" charset="0"/>
              <a:ea typeface="Arial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7602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63</TotalTime>
  <Words>103</Words>
  <Application>Microsoft Office PowerPoint</Application>
  <PresentationFormat>自定义</PresentationFormat>
  <Paragraphs>5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yzyangyan</cp:lastModifiedBy>
  <cp:revision>159</cp:revision>
  <dcterms:created xsi:type="dcterms:W3CDTF">2017-02-03T22:12:08Z</dcterms:created>
  <dcterms:modified xsi:type="dcterms:W3CDTF">2018-08-23T04:39:40Z</dcterms:modified>
</cp:coreProperties>
</file>